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D8F8F9-EE94-4832-9D70-2D356CB7C6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0933D1E-CDE7-4ED6-B2EB-526DB6D4DE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55E4FB-3ACD-4035-91F0-C8A2B59E9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69ABA0-D3C2-4D29-84D2-98C57477E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C9D8B25-8587-457F-A578-A8518A278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7391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BC70F8-4DE7-4A3D-BD0C-699A88FED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D50D390-AA9B-4113-8182-A1BDB84E63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53F308-30A1-4E3F-BF78-23BCE24F9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292A30-5A9D-4C54-B5F9-A67BDB93C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5BD9A9-5222-4FF9-8848-022AAED57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212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D7F7180-89BE-4B62-9D1A-4AAF47C0AE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4DB85F-563D-4E3F-AE59-3C77A5BA01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A7DAEA-D9B9-48F0-B490-E51D7BA2B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C182B0-B755-465B-81CE-9BFDC9045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BC8845-C419-4C8C-9370-27187EA6D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9036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FA159E-BEE3-41CB-9A56-9B0E911993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AE0B25-68C4-4C84-B130-4002168EA2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A045B6-90AC-4067-AAED-A768313EF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9D507B-9F5F-4350-B92E-4B2BC3C1D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B0D50A-DF90-48DD-96B3-C44BBF15A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8887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2AD006-C4A9-4CA3-99A3-4A6F37A155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3F54DE5-ECCE-43B0-A3F5-62B6EF973B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71D937-55AB-411C-869B-682F3C22C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0781F34-C0F4-4F81-89CF-050A3B174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61A184-BA2F-45C4-A185-11C7E017A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194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15B7CF-FFC4-4F15-9C71-153590E7CF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BD26725-39C2-4A98-B4A2-ADB26DB8B6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BA9216B-6BCF-4CF7-919B-5D414C29AC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8AF3C9-359F-4E93-AF26-565E2DD5D9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FFF6F1F-CBF3-4CE6-B0CF-4FCADE93F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1801588-C70B-4D08-A956-735C4F3B5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7394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1F5624-EFA7-4A44-9CCD-2D972C36B8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FA617FF-ECA8-42D6-83EA-EAA61EA88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346D1E3-86EB-40F2-8453-3086ADE372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7285453-CAF1-47E0-A5C0-33EF9911A2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A197062-66C2-4138-BC95-09FE9987C6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75E6B17-F8C4-4D70-A3F6-03F36E03F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317DA4E-A7B5-4CBE-9CA3-41930B320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C8429BD-3DF4-4587-BD55-7187CCB71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0433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1F0041-DB33-4359-9527-3011F3DED5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297E5A7-9E67-4B38-819D-77B5A408D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B936D47-1773-444D-A1C3-C0F93D822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EF34480-6577-430F-8033-CA14CFC20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6498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C713AC-5AD4-478D-9548-222B5A2A4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9F4068C-A0B4-42C1-B878-00D951A1C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AEC8AFE-730B-41B0-B6D8-025D85AD7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5839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6BCDAC-4FAD-451B-AF7C-AAF4CCC17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07D1B2D-9C8E-4C8D-8328-5CD71F0C64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787456C-92D1-4EB4-93CE-37AABDB356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21A52B-C12B-49FD-B16A-8F23F1F7D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377236-BCC7-4922-8B1A-F68D0CFB1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CA3D89-648B-471F-AAED-515CF0D0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303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AE6843-F32B-41DC-BC4B-337EBF929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7FCC3F2-1D6D-4F4E-B46B-2A440B6FCA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B51ED8-1021-47CF-9489-810F3F924F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BC6DE2E-A907-47DA-A6CC-C94A9CBD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6AF5D1C-18C8-4DE8-996F-81278B5AF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7EA82B-1C1C-41BE-A124-F7F7BE6C9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556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307700F-DF6A-4761-A619-766E38F60B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7750D87-CBC4-4738-A579-BD63D5AE0C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799FAF8-4579-4C46-B9B9-50DA917104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36A4C-3086-4886-99AB-C4440DB26B9F}" type="datetimeFigureOut">
              <a:rPr lang="zh-CN" altLang="en-US" smtClean="0"/>
              <a:t>2021/11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9420D99-9AED-4412-88CA-8DDF2BBB36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B8C31F-328F-422F-8218-3A97D4B76B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8E869-A4D0-42B2-B70E-2862E7DC14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7200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3" Type="http://schemas.openxmlformats.org/officeDocument/2006/relationships/image" Target="../media/image9.jpg"/><Relationship Id="rId7" Type="http://schemas.openxmlformats.org/officeDocument/2006/relationships/image" Target="../media/image12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g"/><Relationship Id="rId5" Type="http://schemas.openxmlformats.org/officeDocument/2006/relationships/image" Target="../media/image4.jpg"/><Relationship Id="rId4" Type="http://schemas.openxmlformats.org/officeDocument/2006/relationships/image" Target="../media/image10.jpg"/><Relationship Id="rId9" Type="http://schemas.openxmlformats.org/officeDocument/2006/relationships/image" Target="../media/image1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CD802A1-8FFA-4797-BBAE-6262863F1F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458" y="1453244"/>
            <a:ext cx="2482752" cy="166551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5305A9F-4B18-4313-B85E-F0A2406508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2582" y="1453244"/>
            <a:ext cx="2482752" cy="166551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4021D9B-3058-47DC-9572-75B45127F4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458" y="4229103"/>
            <a:ext cx="2482752" cy="166551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FE55C5A-07AC-420E-9A0C-FF45D82944E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2582" y="4229102"/>
            <a:ext cx="2482752" cy="1665513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087D680-7972-41FE-888F-47C32BAAC944}"/>
              </a:ext>
            </a:extLst>
          </p:cNvPr>
          <p:cNvSpPr txBox="1"/>
          <p:nvPr/>
        </p:nvSpPr>
        <p:spPr>
          <a:xfrm>
            <a:off x="1740349" y="3150710"/>
            <a:ext cx="12811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CE1FAB4-140C-4247-8FBC-C2AC67E62E35}"/>
              </a:ext>
            </a:extLst>
          </p:cNvPr>
          <p:cNvSpPr txBox="1"/>
          <p:nvPr/>
        </p:nvSpPr>
        <p:spPr>
          <a:xfrm>
            <a:off x="1830117" y="6013657"/>
            <a:ext cx="1101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A8DCFA6-788E-45F9-BAA4-354EBA3CF8A3}"/>
              </a:ext>
            </a:extLst>
          </p:cNvPr>
          <p:cNvSpPr txBox="1"/>
          <p:nvPr/>
        </p:nvSpPr>
        <p:spPr>
          <a:xfrm>
            <a:off x="3594310" y="3157560"/>
            <a:ext cx="30267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98BFBBB-AF27-4D4E-BF97-FF74FD814A88}"/>
              </a:ext>
            </a:extLst>
          </p:cNvPr>
          <p:cNvSpPr txBox="1"/>
          <p:nvPr/>
        </p:nvSpPr>
        <p:spPr>
          <a:xfrm>
            <a:off x="3594310" y="6044907"/>
            <a:ext cx="28472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857BE7C5-7F89-4CFC-8F48-C1F0FF08FB8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8815" y="1445127"/>
            <a:ext cx="2494852" cy="167363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852D932F-57D9-473A-B888-103791A3480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1939" y="1453244"/>
            <a:ext cx="2494852" cy="167363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F67928B2-5E81-427B-A0C4-506FC544121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8815" y="4220985"/>
            <a:ext cx="2494852" cy="1673630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1998F04-A1C2-4371-82A2-41296001CCF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4039" y="4229102"/>
            <a:ext cx="2482752" cy="1665513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C41A0DB8-8047-4BEB-B79F-5DF8CCBE11BE}"/>
              </a:ext>
            </a:extLst>
          </p:cNvPr>
          <p:cNvSpPr txBox="1"/>
          <p:nvPr/>
        </p:nvSpPr>
        <p:spPr>
          <a:xfrm>
            <a:off x="7311248" y="3150710"/>
            <a:ext cx="12811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2F58316-B8E6-4702-8794-CF8914520950}"/>
              </a:ext>
            </a:extLst>
          </p:cNvPr>
          <p:cNvSpPr txBox="1"/>
          <p:nvPr/>
        </p:nvSpPr>
        <p:spPr>
          <a:xfrm>
            <a:off x="9165209" y="3157560"/>
            <a:ext cx="30267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62C02CE-A763-4099-B21C-B8C6835F6A5F}"/>
              </a:ext>
            </a:extLst>
          </p:cNvPr>
          <p:cNvSpPr txBox="1"/>
          <p:nvPr/>
        </p:nvSpPr>
        <p:spPr>
          <a:xfrm>
            <a:off x="7489474" y="5982407"/>
            <a:ext cx="1101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C25415C-9AD3-4D6E-9A06-40402EBD934E}"/>
              </a:ext>
            </a:extLst>
          </p:cNvPr>
          <p:cNvSpPr txBox="1"/>
          <p:nvPr/>
        </p:nvSpPr>
        <p:spPr>
          <a:xfrm>
            <a:off x="9253667" y="6013657"/>
            <a:ext cx="284725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4FF5DD9-CDF2-40E4-9386-7F5BECC2FD85}"/>
              </a:ext>
            </a:extLst>
          </p:cNvPr>
          <p:cNvSpPr txBox="1"/>
          <p:nvPr/>
        </p:nvSpPr>
        <p:spPr>
          <a:xfrm>
            <a:off x="4652277" y="394253"/>
            <a:ext cx="32928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serum induce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989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1087D680-7972-41FE-888F-47C32BAAC944}"/>
              </a:ext>
            </a:extLst>
          </p:cNvPr>
          <p:cNvSpPr txBox="1"/>
          <p:nvPr/>
        </p:nvSpPr>
        <p:spPr>
          <a:xfrm>
            <a:off x="1740349" y="3150710"/>
            <a:ext cx="1191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CE1FAB4-140C-4247-8FBC-C2AC67E62E35}"/>
              </a:ext>
            </a:extLst>
          </p:cNvPr>
          <p:cNvSpPr txBox="1"/>
          <p:nvPr/>
        </p:nvSpPr>
        <p:spPr>
          <a:xfrm>
            <a:off x="1830117" y="6013657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8I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A8DCFA6-788E-45F9-BAA4-354EBA3CF8A3}"/>
              </a:ext>
            </a:extLst>
          </p:cNvPr>
          <p:cNvSpPr txBox="1"/>
          <p:nvPr/>
        </p:nvSpPr>
        <p:spPr>
          <a:xfrm>
            <a:off x="3594310" y="3157560"/>
            <a:ext cx="275748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98BFBBB-AF27-4D4E-BF97-FF74FD814A88}"/>
              </a:ext>
            </a:extLst>
          </p:cNvPr>
          <p:cNvSpPr txBox="1"/>
          <p:nvPr/>
        </p:nvSpPr>
        <p:spPr>
          <a:xfrm>
            <a:off x="3594310" y="6044907"/>
            <a:ext cx="24593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8I</a:t>
            </a: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4FF5DD9-CDF2-40E4-9386-7F5BECC2FD85}"/>
              </a:ext>
            </a:extLst>
          </p:cNvPr>
          <p:cNvSpPr txBox="1"/>
          <p:nvPr/>
        </p:nvSpPr>
        <p:spPr>
          <a:xfrm>
            <a:off x="4652277" y="394253"/>
            <a:ext cx="19479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8I</a:t>
            </a: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pplie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C645FD7-3985-41FA-B58C-260E6B6318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7358" y="1483930"/>
            <a:ext cx="2494852" cy="167363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19B981F-F59C-47E6-9AB8-B45C56DF2D9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3660" y="1487166"/>
            <a:ext cx="2540595" cy="170431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43375501-7170-44D6-B518-D7F7FDF6D4C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3407" y="4212068"/>
            <a:ext cx="2482754" cy="166551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C12C0A8D-2481-47DA-B77B-F495B831E64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8815" y="1521910"/>
            <a:ext cx="2488803" cy="1669572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A34256FC-8960-469E-BF0E-4F6D92014D2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4039" y="1506567"/>
            <a:ext cx="2482752" cy="1665513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64D5C7D1-09B1-4702-9E7A-B21ADC01D2D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8815" y="4212067"/>
            <a:ext cx="2482752" cy="1665513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C8E54182-6358-49C0-BE0C-48493401023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4039" y="4212066"/>
            <a:ext cx="2482752" cy="1665513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20D7A55B-0F68-47BA-A0C1-E3C13302527E}"/>
              </a:ext>
            </a:extLst>
          </p:cNvPr>
          <p:cNvSpPr txBox="1"/>
          <p:nvPr/>
        </p:nvSpPr>
        <p:spPr>
          <a:xfrm>
            <a:off x="7580553" y="3168279"/>
            <a:ext cx="1191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E60E8FF-3EC6-43A6-AF4A-96A2D3084395}"/>
              </a:ext>
            </a:extLst>
          </p:cNvPr>
          <p:cNvSpPr txBox="1"/>
          <p:nvPr/>
        </p:nvSpPr>
        <p:spPr>
          <a:xfrm>
            <a:off x="9434514" y="3175129"/>
            <a:ext cx="275748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psis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B1CF451-E574-4F15-813F-A64504469DC9}"/>
              </a:ext>
            </a:extLst>
          </p:cNvPr>
          <p:cNvSpPr txBox="1"/>
          <p:nvPr/>
        </p:nvSpPr>
        <p:spPr>
          <a:xfrm>
            <a:off x="7739846" y="6013657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8I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F909196A-09D3-4912-A55C-8453B0F9F354}"/>
              </a:ext>
            </a:extLst>
          </p:cNvPr>
          <p:cNvSpPr txBox="1"/>
          <p:nvPr/>
        </p:nvSpPr>
        <p:spPr>
          <a:xfrm>
            <a:off x="9504039" y="6044907"/>
            <a:ext cx="24593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8I</a:t>
            </a:r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arrow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7B919353-A46C-43AE-A4A4-06EEE4274A2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3660" y="4202364"/>
            <a:ext cx="2511675" cy="1684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7498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37</Words>
  <Application>Microsoft Office PowerPoint</Application>
  <PresentationFormat>宽屏</PresentationFormat>
  <Paragraphs>1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 xiao</dc:creator>
  <cp:lastModifiedBy>F xiao</cp:lastModifiedBy>
  <cp:revision>1</cp:revision>
  <dcterms:created xsi:type="dcterms:W3CDTF">2021-11-14T12:51:12Z</dcterms:created>
  <dcterms:modified xsi:type="dcterms:W3CDTF">2021-11-14T13:07:59Z</dcterms:modified>
</cp:coreProperties>
</file>